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31" userDrawn="1">
          <p15:clr>
            <a:srgbClr val="A4A3A4"/>
          </p15:clr>
        </p15:guide>
        <p15:guide id="2" pos="10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bw"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Objects="1" showGuides="1">
      <p:cViewPr varScale="1">
        <p:scale>
          <a:sx n="53" d="100"/>
          <a:sy n="53" d="100"/>
        </p:scale>
        <p:origin x="2910" y="90"/>
      </p:cViewPr>
      <p:guideLst>
        <p:guide orient="horz" pos="2031"/>
        <p:guide pos="102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6A1D8-8DD4-3242-9E69-AB889ED64A64}" type="datetimeFigureOut">
              <a:rPr lang="en-US" smtClean="0"/>
              <a:pPr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7237CE-828B-2C46-8DF2-39C1ED2B872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532B1AF-5A26-4D64-9ADC-7FEF7C62CE41}"/>
              </a:ext>
            </a:extLst>
          </p:cNvPr>
          <p:cNvSpPr txBox="1"/>
          <p:nvPr/>
        </p:nvSpPr>
        <p:spPr>
          <a:xfrm>
            <a:off x="4653136" y="9536668"/>
            <a:ext cx="2136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/>
              <a:t>Supplementary Fig 1</a:t>
            </a:r>
            <a:endParaRPr lang="en-US" b="1" dirty="0"/>
          </a:p>
        </p:txBody>
      </p:sp>
      <p:grpSp>
        <p:nvGrpSpPr>
          <p:cNvPr id="4" name="Group 4">
            <a:extLst>
              <a:ext uri="{FF2B5EF4-FFF2-40B4-BE49-F238E27FC236}">
                <a16:creationId xmlns:a16="http://schemas.microsoft.com/office/drawing/2014/main" id="{8D3EA108-6ECA-4DBB-972C-DFE7F06F7C78}"/>
              </a:ext>
            </a:extLst>
          </p:cNvPr>
          <p:cNvGrpSpPr>
            <a:grpSpLocks/>
          </p:cNvGrpSpPr>
          <p:nvPr/>
        </p:nvGrpSpPr>
        <p:grpSpPr bwMode="auto">
          <a:xfrm>
            <a:off x="2039582" y="1784648"/>
            <a:ext cx="3524250" cy="1540189"/>
            <a:chOff x="2127250" y="2134152"/>
            <a:chExt cx="3524250" cy="1540911"/>
          </a:xfrm>
        </p:grpSpPr>
        <p:pic>
          <p:nvPicPr>
            <p:cNvPr id="5" name="Picture 3">
              <a:extLst>
                <a:ext uri="{FF2B5EF4-FFF2-40B4-BE49-F238E27FC236}">
                  <a16:creationId xmlns:a16="http://schemas.microsoft.com/office/drawing/2014/main" id="{0A0BBC16-20D7-47E6-8AD1-894E016205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29" t="27196" r="31118" b="18010"/>
            <a:stretch/>
          </p:blipFill>
          <p:spPr bwMode="auto">
            <a:xfrm>
              <a:off x="2127250" y="2933700"/>
              <a:ext cx="2660451" cy="741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TextBox 4">
              <a:extLst>
                <a:ext uri="{FF2B5EF4-FFF2-40B4-BE49-F238E27FC236}">
                  <a16:creationId xmlns:a16="http://schemas.microsoft.com/office/drawing/2014/main" id="{C47D436A-5B48-46DA-A0FF-AD2153D57D4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95513" y="2708275"/>
              <a:ext cx="3455987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nl-NL" altLang="en-BE" sz="1200" dirty="0"/>
                <a:t>A549</a:t>
              </a:r>
              <a:endParaRPr lang="en-GB" altLang="en-BE" sz="1200" dirty="0"/>
            </a:p>
          </p:txBody>
        </p:sp>
        <p:sp>
          <p:nvSpPr>
            <p:cNvPr id="7" name="TextBox 1">
              <a:extLst>
                <a:ext uri="{FF2B5EF4-FFF2-40B4-BE49-F238E27FC236}">
                  <a16:creationId xmlns:a16="http://schemas.microsoft.com/office/drawing/2014/main" id="{57A08236-5944-494D-B708-F031F5A025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21732" y="2134152"/>
              <a:ext cx="2379810" cy="277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nl-NL" altLang="en-BE" sz="1200" dirty="0"/>
                <a:t>                NHBE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6045F6C9-5E77-46C1-A772-8BB3B9D7B120}"/>
              </a:ext>
            </a:extLst>
          </p:cNvPr>
          <p:cNvSpPr txBox="1"/>
          <p:nvPr/>
        </p:nvSpPr>
        <p:spPr>
          <a:xfrm>
            <a:off x="3057814" y="2114850"/>
            <a:ext cx="1440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on </a:t>
            </a:r>
          </a:p>
          <a:p>
            <a:r>
              <a:rPr lang="en-US" sz="1200" dirty="0"/>
              <a:t>Washed</a:t>
            </a:r>
            <a:endParaRPr lang="en-BE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78C140-45FB-4F4E-9B00-3EAC6854FA85}"/>
              </a:ext>
            </a:extLst>
          </p:cNvPr>
          <p:cNvSpPr txBox="1"/>
          <p:nvPr/>
        </p:nvSpPr>
        <p:spPr>
          <a:xfrm>
            <a:off x="3943788" y="2106801"/>
            <a:ext cx="6842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 </a:t>
            </a:r>
          </a:p>
          <a:p>
            <a:r>
              <a:rPr lang="en-US" sz="1200" dirty="0"/>
              <a:t>Washed</a:t>
            </a:r>
            <a:endParaRPr lang="en-BE" sz="1200" dirty="0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DDDB77A-4A7A-46A1-B3B8-1B19A8CF66F7}"/>
              </a:ext>
            </a:extLst>
          </p:cNvPr>
          <p:cNvCxnSpPr/>
          <p:nvPr/>
        </p:nvCxnSpPr>
        <p:spPr>
          <a:xfrm>
            <a:off x="3187865" y="2114850"/>
            <a:ext cx="13101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48593C03-5161-4FB1-8DD7-3285D9A15503}"/>
              </a:ext>
            </a:extLst>
          </p:cNvPr>
          <p:cNvSpPr txBox="1"/>
          <p:nvPr/>
        </p:nvSpPr>
        <p:spPr>
          <a:xfrm flipH="1">
            <a:off x="205377" y="3981043"/>
            <a:ext cx="65527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100" b="1" dirty="0"/>
              <a:t>S1. Glycan rich composition is maintained on HAE cells after wash with PBS. </a:t>
            </a:r>
            <a:r>
              <a:rPr lang="en-AU" sz="1100" dirty="0"/>
              <a:t>A549 or HAE cells</a:t>
            </a:r>
            <a:r>
              <a:rPr lang="en-AU" sz="1100" b="1" dirty="0"/>
              <a:t> </a:t>
            </a:r>
            <a:r>
              <a:rPr lang="en-AU" sz="1100" dirty="0"/>
              <a:t>washed 3x with PBS or non washed were stained with Periodic Acid-Schiff. </a:t>
            </a:r>
            <a:endParaRPr lang="en-BE" sz="11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83</TotalTime>
  <Words>42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elbourn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mma J</dc:creator>
  <cp:lastModifiedBy>Joao Paulo Portela Catani</cp:lastModifiedBy>
  <cp:revision>112</cp:revision>
  <cp:lastPrinted>2013-02-15T05:32:38Z</cp:lastPrinted>
  <dcterms:created xsi:type="dcterms:W3CDTF">2015-06-01T17:06:44Z</dcterms:created>
  <dcterms:modified xsi:type="dcterms:W3CDTF">2022-01-20T15:26:41Z</dcterms:modified>
</cp:coreProperties>
</file>